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73"/>
    <a:srgbClr val="BFBFBF"/>
    <a:srgbClr val="8D8DFF"/>
    <a:srgbClr val="4FB6E9"/>
    <a:srgbClr val="9001D4"/>
    <a:srgbClr val="019E73"/>
    <a:srgbClr val="000080"/>
    <a:srgbClr val="C8D1E2"/>
    <a:srgbClr val="FFFFFF"/>
    <a:srgbClr val="90BF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–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 autoAdjust="0"/>
    <p:restoredTop sz="94384" autoAdjust="0"/>
  </p:normalViewPr>
  <p:slideViewPr>
    <p:cSldViewPr snapToGrid="0">
      <p:cViewPr varScale="1">
        <p:scale>
          <a:sx n="84" d="100"/>
          <a:sy n="84" d="100"/>
        </p:scale>
        <p:origin x="3848" y="1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3D69F-7222-B14D-9E01-39F81D144C7F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E3D8AD-4781-4F42-A424-48FC4D64EB44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76326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E3D8AD-4781-4F42-A424-48FC4D64EB44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90513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76817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182891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33420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0135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81604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41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31247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2942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8387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17488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3391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7436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F0BC518-4851-ED5A-3E03-8E3737127D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8857853"/>
              </p:ext>
            </p:extLst>
          </p:nvPr>
        </p:nvGraphicFramePr>
        <p:xfrm>
          <a:off x="563577" y="423251"/>
          <a:ext cx="5801009" cy="8445456"/>
        </p:xfrm>
        <a:graphic>
          <a:graphicData uri="http://schemas.openxmlformats.org/drawingml/2006/table">
            <a:tbl>
              <a:tblPr firstRow="1" bandRow="1">
                <a:tableStyleId>{69C7853C-536D-4A76-A0AE-DD22124D55A5}</a:tableStyleId>
              </a:tblPr>
              <a:tblGrid>
                <a:gridCol w="827309">
                  <a:extLst>
                    <a:ext uri="{9D8B030D-6E8A-4147-A177-3AD203B41FA5}">
                      <a16:colId xmlns:a16="http://schemas.microsoft.com/office/drawing/2014/main" val="1561436807"/>
                    </a:ext>
                  </a:extLst>
                </a:gridCol>
                <a:gridCol w="678132">
                  <a:extLst>
                    <a:ext uri="{9D8B030D-6E8A-4147-A177-3AD203B41FA5}">
                      <a16:colId xmlns:a16="http://schemas.microsoft.com/office/drawing/2014/main" val="926654277"/>
                    </a:ext>
                  </a:extLst>
                </a:gridCol>
                <a:gridCol w="542419">
                  <a:extLst>
                    <a:ext uri="{9D8B030D-6E8A-4147-A177-3AD203B41FA5}">
                      <a16:colId xmlns:a16="http://schemas.microsoft.com/office/drawing/2014/main" val="1992594911"/>
                    </a:ext>
                  </a:extLst>
                </a:gridCol>
                <a:gridCol w="625159">
                  <a:extLst>
                    <a:ext uri="{9D8B030D-6E8A-4147-A177-3AD203B41FA5}">
                      <a16:colId xmlns:a16="http://schemas.microsoft.com/office/drawing/2014/main" val="99637737"/>
                    </a:ext>
                  </a:extLst>
                </a:gridCol>
                <a:gridCol w="1054747">
                  <a:extLst>
                    <a:ext uri="{9D8B030D-6E8A-4147-A177-3AD203B41FA5}">
                      <a16:colId xmlns:a16="http://schemas.microsoft.com/office/drawing/2014/main" val="3238638767"/>
                    </a:ext>
                  </a:extLst>
                </a:gridCol>
                <a:gridCol w="2073243">
                  <a:extLst>
                    <a:ext uri="{9D8B030D-6E8A-4147-A177-3AD203B41FA5}">
                      <a16:colId xmlns:a16="http://schemas.microsoft.com/office/drawing/2014/main" val="2735641678"/>
                    </a:ext>
                  </a:extLst>
                </a:gridCol>
              </a:tblGrid>
              <a:tr h="229112">
                <a:tc gridSpan="6">
                  <a:txBody>
                    <a:bodyPr/>
                    <a:lstStyle/>
                    <a:p>
                      <a:pPr algn="l"/>
                      <a:r>
                        <a:rPr lang="en-GB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5 Table </a:t>
                      </a:r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 Primers employed for cloning.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1374887"/>
                  </a:ext>
                </a:extLst>
              </a:tr>
              <a:tr h="229112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struct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 range </a:t>
                      </a:r>
                      <a:r>
                        <a:rPr lang="en-GB" sz="14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W</a:t>
                      </a:r>
                    </a:p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GB" sz="11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hang </a:t>
                      </a:r>
                      <a:r>
                        <a:rPr lang="en-GB" sz="1400" b="1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nding region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5748920"/>
                  </a:ext>
                </a:extLst>
              </a:tr>
              <a:tr h="140879">
                <a:tc gridSpan="6">
                  <a:txBody>
                    <a:bodyPr/>
                    <a:lstStyle/>
                    <a:p>
                      <a:pPr algn="l"/>
                      <a:r>
                        <a:rPr lang="en-GB" sz="11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se</a:t>
                      </a:r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ariants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6773902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1–E319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AGCAAGCCGGACATCAAAG</a:t>
                      </a:r>
                      <a:r>
                        <a:rPr lang="en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3035132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CCGCCGGCTCGCTAATG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6599065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–2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1–V631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AGCAAGCCGGACATCAA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4050115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CAGTTGGCTCATACGCTTAA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302669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–3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1–Q80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AGCAAGCCGGACATCAA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754066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GGGTTTCGGTGTTATCGTC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6179120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–4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1–N87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AGCAAGCCGGACATCAA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0320351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TTTATAGTAATAGGTAACCAC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55773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–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1-I116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AGCAAGCCGGACATCAA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3959501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TCTCAACCGCGCTACGTTTGT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3734013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28–V631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ACCGAGCAGAGCATCCA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5201458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CAGTTGGCTCATACGCTTAA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2912409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–4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28–N87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ACCGAGCAGAGCATCCA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1946728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G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TTTATAGTAATAGGTAACCAC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7696749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–5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28–T100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ACCGAGCAGAGCATCCA</a:t>
                      </a:r>
                      <a:r>
                        <a:rPr lang="en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5570725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CGGTGCTCGGAATCGG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029976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877–T100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GAACGAGGAACACACCCAC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0836204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CGGTGCTCGGAATCGG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2415381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–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877–G1170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GAACGAGGAACACACCCAC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982716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CGGTCGCCGGAATCTC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7108914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007–T109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CGAACTGAAGATCATTGCGG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6086956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TACGCACGGTCAGGTTC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982865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100–G1170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T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GGTCACATTCACGACTACG</a:t>
                      </a:r>
                      <a:r>
                        <a:rPr lang="en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8308133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s-E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GA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s-E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CGGTCGCCGGAATCTC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3496453"/>
                  </a:ext>
                </a:extLst>
              </a:tr>
              <a:tr h="138925">
                <a:tc gridSpan="6">
                  <a:txBody>
                    <a:bodyPr/>
                    <a:lstStyle/>
                    <a:p>
                      <a:pPr algn="l"/>
                      <a:r>
                        <a: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 variants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5707527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2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E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LC) </a:t>
                      </a:r>
                      <a:r>
                        <a:rPr lang="en-GB" sz="9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l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l-G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S</a:t>
                      </a:r>
                      <a:r>
                        <a:rPr lang="el-G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7</a:t>
                      </a:r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GAC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u="sng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TCTGCCCTGACTCAG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1573657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AT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ATCGC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ATGAACATTCTGTAGGGGCCT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0182817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2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1</a:t>
                      </a:r>
                    </a:p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HC) </a:t>
                      </a:r>
                      <a:r>
                        <a:rPr lang="en-GB" sz="9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lp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–P444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GG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GACTGGACCTGGAGGAT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4774132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ATCGC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TTTACCCGCCAAGCG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887336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2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2 </a:t>
                      </a:r>
                      <a:endParaRPr lang="es-ES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HC) </a:t>
                      </a:r>
                      <a:r>
                        <a:rPr lang="es-E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9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l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–S330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GG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GACTGGACCTGGAGGAT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0077466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ATCGC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ATTTTGTGATGTTGGCGGTTAG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9210587"/>
                  </a:ext>
                </a:extLst>
              </a:tr>
              <a:tr h="13892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2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s-E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l-GR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)  </a:t>
                      </a:r>
                      <a:r>
                        <a:rPr lang="en-GB" sz="9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l</a:t>
                      </a:r>
                      <a:r>
                        <a:rPr lang="en-GB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7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–P229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CGGG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GACTGGACCTGGAGGAT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384730"/>
                  </a:ext>
                </a:extLst>
              </a:tr>
              <a:tr h="138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AT</a:t>
                      </a:r>
                      <a:r>
                        <a:rPr lang="en-US" sz="800" u="sng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ATCGC</a:t>
                      </a:r>
                      <a:endParaRPr lang="en-ES" sz="800" u="sng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noFill/>
                      <a:prstDash val="solid"/>
                      <a:miter lim="800000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GGGGAGGTGGGGGAAC</a:t>
                      </a:r>
                      <a:r>
                        <a:rPr lang="en-E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miter lim="800000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4867051"/>
                  </a:ext>
                </a:extLst>
              </a:tr>
              <a:tr h="138925">
                <a:tc gridSpan="6"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mino-acid numbering of</a:t>
                      </a:r>
                      <a:r>
                        <a:rPr lang="es-E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A variants starts with Q</a:t>
                      </a:r>
                      <a:r>
                        <a:rPr lang="en-US" sz="11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mmediately after the signal peptide.</a:t>
                      </a: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Underlined nucleotides indicate restriction-enzyme cleavage sites for molecular cloning. </a:t>
                      </a: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900"/>
                        </a:lnSpc>
                      </a:pPr>
                      <a:endParaRPr lang="en-GB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E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592" marR="90592" marT="45296" marB="45296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04556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6182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075</TotalTime>
  <Words>253</Words>
  <Application>Microsoft Macintosh PowerPoint</Application>
  <PresentationFormat>A4 Paper (210x297 mm)</PresentationFormat>
  <Paragraphs>16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.X.Gomis-Rüth</dc:creator>
  <cp:lastModifiedBy>F.X.Gomis-Rüth</cp:lastModifiedBy>
  <cp:revision>406</cp:revision>
  <dcterms:created xsi:type="dcterms:W3CDTF">2024-01-16T16:15:53Z</dcterms:created>
  <dcterms:modified xsi:type="dcterms:W3CDTF">2025-06-18T09:56:14Z</dcterms:modified>
</cp:coreProperties>
</file>